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9" r:id="rId3"/>
    <p:sldId id="260" r:id="rId4"/>
    <p:sldId id="258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4004026-7FD7-414B-B9B4-B5699943540A}" v="10" dt="2025-02-07T05:10:42.47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1" autoAdjust="0"/>
    <p:restoredTop sz="94660"/>
  </p:normalViewPr>
  <p:slideViewPr>
    <p:cSldViewPr snapToGrid="0">
      <p:cViewPr>
        <p:scale>
          <a:sx n="100" d="100"/>
          <a:sy n="100" d="100"/>
        </p:scale>
        <p:origin x="1694" y="-6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Yoshiaki Marumo" userId="86324989ca739fff" providerId="LiveId" clId="{C4004026-7FD7-414B-B9B4-B5699943540A}"/>
    <pc:docChg chg="undo custSel addSld modSld">
      <pc:chgData name="Yoshiaki Marumo" userId="86324989ca739fff" providerId="LiveId" clId="{C4004026-7FD7-414B-B9B4-B5699943540A}" dt="2025-02-07T05:11:10.187" v="59"/>
      <pc:docMkLst>
        <pc:docMk/>
      </pc:docMkLst>
      <pc:sldChg chg="addSp modSp mod">
        <pc:chgData name="Yoshiaki Marumo" userId="86324989ca739fff" providerId="LiveId" clId="{C4004026-7FD7-414B-B9B4-B5699943540A}" dt="2025-02-07T05:10:37.210" v="53" actId="20577"/>
        <pc:sldMkLst>
          <pc:docMk/>
          <pc:sldMk cId="3330923997" sldId="258"/>
        </pc:sldMkLst>
        <pc:spChg chg="add mod">
          <ac:chgData name="Yoshiaki Marumo" userId="86324989ca739fff" providerId="LiveId" clId="{C4004026-7FD7-414B-B9B4-B5699943540A}" dt="2025-02-07T05:10:20.765" v="48" actId="1076"/>
          <ac:spMkLst>
            <pc:docMk/>
            <pc:sldMk cId="3330923997" sldId="258"/>
            <ac:spMk id="2" creationId="{38C3738F-EBCE-316E-C97C-34F9F9FFFACF}"/>
          </ac:spMkLst>
        </pc:spChg>
        <pc:spChg chg="mod">
          <ac:chgData name="Yoshiaki Marumo" userId="86324989ca739fff" providerId="LiveId" clId="{C4004026-7FD7-414B-B9B4-B5699943540A}" dt="2025-02-07T05:10:37.210" v="53" actId="20577"/>
          <ac:spMkLst>
            <pc:docMk/>
            <pc:sldMk cId="3330923997" sldId="258"/>
            <ac:spMk id="148" creationId="{FC9311E5-6973-2EB0-DEAE-C5DAB057C846}"/>
          </ac:spMkLst>
        </pc:spChg>
        <pc:picChg chg="mod">
          <ac:chgData name="Yoshiaki Marumo" userId="86324989ca739fff" providerId="LiveId" clId="{C4004026-7FD7-414B-B9B4-B5699943540A}" dt="2025-02-07T05:10:02.465" v="43" actId="1076"/>
          <ac:picMkLst>
            <pc:docMk/>
            <pc:sldMk cId="3330923997" sldId="258"/>
            <ac:picMk id="9" creationId="{9C3CA941-4F30-67ED-10CD-F9BFE042B8CE}"/>
          </ac:picMkLst>
        </pc:picChg>
      </pc:sldChg>
      <pc:sldChg chg="addSp delSp modSp new mod">
        <pc:chgData name="Yoshiaki Marumo" userId="86324989ca739fff" providerId="LiveId" clId="{C4004026-7FD7-414B-B9B4-B5699943540A}" dt="2025-02-07T05:11:10.187" v="59"/>
        <pc:sldMkLst>
          <pc:docMk/>
          <pc:sldMk cId="2658527185" sldId="260"/>
        </pc:sldMkLst>
        <pc:spChg chg="del">
          <ac:chgData name="Yoshiaki Marumo" userId="86324989ca739fff" providerId="LiveId" clId="{C4004026-7FD7-414B-B9B4-B5699943540A}" dt="2025-02-07T05:07:48.047" v="2" actId="478"/>
          <ac:spMkLst>
            <pc:docMk/>
            <pc:sldMk cId="2658527185" sldId="260"/>
            <ac:spMk id="2" creationId="{68101F76-B4EB-6244-0EC0-B365196F0679}"/>
          </ac:spMkLst>
        </pc:spChg>
        <pc:spChg chg="del">
          <ac:chgData name="Yoshiaki Marumo" userId="86324989ca739fff" providerId="LiveId" clId="{C4004026-7FD7-414B-B9B4-B5699943540A}" dt="2025-02-07T05:07:46.296" v="1" actId="478"/>
          <ac:spMkLst>
            <pc:docMk/>
            <pc:sldMk cId="2658527185" sldId="260"/>
            <ac:spMk id="3" creationId="{14CF8562-5F98-C325-D98E-B3D54D456A1E}"/>
          </ac:spMkLst>
        </pc:spChg>
        <pc:spChg chg="add mod">
          <ac:chgData name="Yoshiaki Marumo" userId="86324989ca739fff" providerId="LiveId" clId="{C4004026-7FD7-414B-B9B4-B5699943540A}" dt="2025-02-07T05:08:09.027" v="3"/>
          <ac:spMkLst>
            <pc:docMk/>
            <pc:sldMk cId="2658527185" sldId="260"/>
            <ac:spMk id="8" creationId="{B609B769-6DEC-3F71-181A-A97FCEA63194}"/>
          </ac:spMkLst>
        </pc:spChg>
        <pc:spChg chg="add mod">
          <ac:chgData name="Yoshiaki Marumo" userId="86324989ca739fff" providerId="LiveId" clId="{C4004026-7FD7-414B-B9B4-B5699943540A}" dt="2025-02-07T05:08:09.027" v="3"/>
          <ac:spMkLst>
            <pc:docMk/>
            <pc:sldMk cId="2658527185" sldId="260"/>
            <ac:spMk id="9" creationId="{48621E17-3B9B-3040-4AB7-D15636233E87}"/>
          </ac:spMkLst>
        </pc:spChg>
        <pc:spChg chg="add mod">
          <ac:chgData name="Yoshiaki Marumo" userId="86324989ca739fff" providerId="LiveId" clId="{C4004026-7FD7-414B-B9B4-B5699943540A}" dt="2025-02-07T05:08:09.027" v="3"/>
          <ac:spMkLst>
            <pc:docMk/>
            <pc:sldMk cId="2658527185" sldId="260"/>
            <ac:spMk id="10" creationId="{3191DAFF-161B-46EC-35A7-90AC2AF52D4E}"/>
          </ac:spMkLst>
        </pc:spChg>
        <pc:spChg chg="add mod">
          <ac:chgData name="Yoshiaki Marumo" userId="86324989ca739fff" providerId="LiveId" clId="{C4004026-7FD7-414B-B9B4-B5699943540A}" dt="2025-02-07T05:08:09.027" v="3"/>
          <ac:spMkLst>
            <pc:docMk/>
            <pc:sldMk cId="2658527185" sldId="260"/>
            <ac:spMk id="11" creationId="{23CE2E74-DC3C-8703-E9C7-30589AC77EAB}"/>
          </ac:spMkLst>
        </pc:spChg>
        <pc:spChg chg="add mod">
          <ac:chgData name="Yoshiaki Marumo" userId="86324989ca739fff" providerId="LiveId" clId="{C4004026-7FD7-414B-B9B4-B5699943540A}" dt="2025-02-07T05:08:09.027" v="3"/>
          <ac:spMkLst>
            <pc:docMk/>
            <pc:sldMk cId="2658527185" sldId="260"/>
            <ac:spMk id="12" creationId="{2F548233-ED5F-C295-9A52-E7C295E1DB55}"/>
          </ac:spMkLst>
        </pc:spChg>
        <pc:spChg chg="add mod">
          <ac:chgData name="Yoshiaki Marumo" userId="86324989ca739fff" providerId="LiveId" clId="{C4004026-7FD7-414B-B9B4-B5699943540A}" dt="2025-02-07T05:08:09.027" v="3"/>
          <ac:spMkLst>
            <pc:docMk/>
            <pc:sldMk cId="2658527185" sldId="260"/>
            <ac:spMk id="13" creationId="{3F12B4CC-1920-8C2D-726C-626C6C26C74E}"/>
          </ac:spMkLst>
        </pc:spChg>
        <pc:spChg chg="add mod">
          <ac:chgData name="Yoshiaki Marumo" userId="86324989ca739fff" providerId="LiveId" clId="{C4004026-7FD7-414B-B9B4-B5699943540A}" dt="2025-02-07T05:08:09.027" v="3"/>
          <ac:spMkLst>
            <pc:docMk/>
            <pc:sldMk cId="2658527185" sldId="260"/>
            <ac:spMk id="17" creationId="{8166FF4D-9274-0911-1BFE-E2910986DEC6}"/>
          </ac:spMkLst>
        </pc:spChg>
        <pc:spChg chg="add mod">
          <ac:chgData name="Yoshiaki Marumo" userId="86324989ca739fff" providerId="LiveId" clId="{C4004026-7FD7-414B-B9B4-B5699943540A}" dt="2025-02-07T05:08:09.027" v="3"/>
          <ac:spMkLst>
            <pc:docMk/>
            <pc:sldMk cId="2658527185" sldId="260"/>
            <ac:spMk id="18" creationId="{B3A66DC6-4FD6-678D-19CE-9E01A89FEF7E}"/>
          </ac:spMkLst>
        </pc:spChg>
        <pc:spChg chg="add mod">
          <ac:chgData name="Yoshiaki Marumo" userId="86324989ca739fff" providerId="LiveId" clId="{C4004026-7FD7-414B-B9B4-B5699943540A}" dt="2025-02-07T05:08:09.027" v="3"/>
          <ac:spMkLst>
            <pc:docMk/>
            <pc:sldMk cId="2658527185" sldId="260"/>
            <ac:spMk id="19" creationId="{5FAFAF5D-E18F-3453-0982-C86DC4EE6EB4}"/>
          </ac:spMkLst>
        </pc:spChg>
        <pc:spChg chg="add mod">
          <ac:chgData name="Yoshiaki Marumo" userId="86324989ca739fff" providerId="LiveId" clId="{C4004026-7FD7-414B-B9B4-B5699943540A}" dt="2025-02-07T05:08:09.027" v="3"/>
          <ac:spMkLst>
            <pc:docMk/>
            <pc:sldMk cId="2658527185" sldId="260"/>
            <ac:spMk id="20" creationId="{46851B58-C3DE-3DBC-06F1-6633211FA7F6}"/>
          </ac:spMkLst>
        </pc:spChg>
        <pc:spChg chg="add mod">
          <ac:chgData name="Yoshiaki Marumo" userId="86324989ca739fff" providerId="LiveId" clId="{C4004026-7FD7-414B-B9B4-B5699943540A}" dt="2025-02-07T05:08:53.526" v="7"/>
          <ac:spMkLst>
            <pc:docMk/>
            <pc:sldMk cId="2658527185" sldId="260"/>
            <ac:spMk id="27" creationId="{A8BBF070-16E0-6176-9A0C-5EDD7510BD2F}"/>
          </ac:spMkLst>
        </pc:spChg>
        <pc:spChg chg="add mod">
          <ac:chgData name="Yoshiaki Marumo" userId="86324989ca739fff" providerId="LiveId" clId="{C4004026-7FD7-414B-B9B4-B5699943540A}" dt="2025-02-07T05:08:53.526" v="7"/>
          <ac:spMkLst>
            <pc:docMk/>
            <pc:sldMk cId="2658527185" sldId="260"/>
            <ac:spMk id="28" creationId="{4E6173BB-768C-96C3-63DF-921AAC746A81}"/>
          </ac:spMkLst>
        </pc:spChg>
        <pc:spChg chg="add mod">
          <ac:chgData name="Yoshiaki Marumo" userId="86324989ca739fff" providerId="LiveId" clId="{C4004026-7FD7-414B-B9B4-B5699943540A}" dt="2025-02-07T05:08:53.526" v="7"/>
          <ac:spMkLst>
            <pc:docMk/>
            <pc:sldMk cId="2658527185" sldId="260"/>
            <ac:spMk id="29" creationId="{DA905A11-0DB1-392F-8F62-FF4E3581E16A}"/>
          </ac:spMkLst>
        </pc:spChg>
        <pc:spChg chg="add mod">
          <ac:chgData name="Yoshiaki Marumo" userId="86324989ca739fff" providerId="LiveId" clId="{C4004026-7FD7-414B-B9B4-B5699943540A}" dt="2025-02-07T05:08:53.526" v="7"/>
          <ac:spMkLst>
            <pc:docMk/>
            <pc:sldMk cId="2658527185" sldId="260"/>
            <ac:spMk id="30" creationId="{5653C44C-E094-C47C-5494-E372410744E6}"/>
          </ac:spMkLst>
        </pc:spChg>
        <pc:spChg chg="add mod">
          <ac:chgData name="Yoshiaki Marumo" userId="86324989ca739fff" providerId="LiveId" clId="{C4004026-7FD7-414B-B9B4-B5699943540A}" dt="2025-02-07T05:08:53.526" v="7"/>
          <ac:spMkLst>
            <pc:docMk/>
            <pc:sldMk cId="2658527185" sldId="260"/>
            <ac:spMk id="31" creationId="{6271C1CE-9742-4EBE-BD56-8AFD56D2315A}"/>
          </ac:spMkLst>
        </pc:spChg>
        <pc:spChg chg="add mod">
          <ac:chgData name="Yoshiaki Marumo" userId="86324989ca739fff" providerId="LiveId" clId="{C4004026-7FD7-414B-B9B4-B5699943540A}" dt="2025-02-07T05:08:53.526" v="7"/>
          <ac:spMkLst>
            <pc:docMk/>
            <pc:sldMk cId="2658527185" sldId="260"/>
            <ac:spMk id="32" creationId="{A1575624-972A-7121-D314-91CF0EDD0243}"/>
          </ac:spMkLst>
        </pc:spChg>
        <pc:spChg chg="add mod">
          <ac:chgData name="Yoshiaki Marumo" userId="86324989ca739fff" providerId="LiveId" clId="{C4004026-7FD7-414B-B9B4-B5699943540A}" dt="2025-02-07T05:08:53.526" v="7"/>
          <ac:spMkLst>
            <pc:docMk/>
            <pc:sldMk cId="2658527185" sldId="260"/>
            <ac:spMk id="34" creationId="{76ECFBD2-21FE-0C02-6DB2-E184B3C571FD}"/>
          </ac:spMkLst>
        </pc:spChg>
        <pc:spChg chg="add mod">
          <ac:chgData name="Yoshiaki Marumo" userId="86324989ca739fff" providerId="LiveId" clId="{C4004026-7FD7-414B-B9B4-B5699943540A}" dt="2025-02-07T05:08:53.526" v="7"/>
          <ac:spMkLst>
            <pc:docMk/>
            <pc:sldMk cId="2658527185" sldId="260"/>
            <ac:spMk id="35" creationId="{F77DAA9D-AF1D-5C3C-42E1-623DB2B89791}"/>
          </ac:spMkLst>
        </pc:spChg>
        <pc:spChg chg="add mod">
          <ac:chgData name="Yoshiaki Marumo" userId="86324989ca739fff" providerId="LiveId" clId="{C4004026-7FD7-414B-B9B4-B5699943540A}" dt="2025-02-07T05:08:53.526" v="7"/>
          <ac:spMkLst>
            <pc:docMk/>
            <pc:sldMk cId="2658527185" sldId="260"/>
            <ac:spMk id="36" creationId="{AE04909E-90C9-084B-F96B-D0AA1058FFE3}"/>
          </ac:spMkLst>
        </pc:spChg>
        <pc:spChg chg="add mod">
          <ac:chgData name="Yoshiaki Marumo" userId="86324989ca739fff" providerId="LiveId" clId="{C4004026-7FD7-414B-B9B4-B5699943540A}" dt="2025-02-07T05:08:53.526" v="7"/>
          <ac:spMkLst>
            <pc:docMk/>
            <pc:sldMk cId="2658527185" sldId="260"/>
            <ac:spMk id="38" creationId="{70AC123C-C7ED-716B-1EB1-A65555957D70}"/>
          </ac:spMkLst>
        </pc:spChg>
        <pc:spChg chg="add mod">
          <ac:chgData name="Yoshiaki Marumo" userId="86324989ca739fff" providerId="LiveId" clId="{C4004026-7FD7-414B-B9B4-B5699943540A}" dt="2025-02-07T05:11:10.187" v="59"/>
          <ac:spMkLst>
            <pc:docMk/>
            <pc:sldMk cId="2658527185" sldId="260"/>
            <ac:spMk id="41" creationId="{C64764CD-084A-4D55-6371-7B010BDFA475}"/>
          </ac:spMkLst>
        </pc:spChg>
        <pc:picChg chg="add del mod">
          <ac:chgData name="Yoshiaki Marumo" userId="86324989ca739fff" providerId="LiveId" clId="{C4004026-7FD7-414B-B9B4-B5699943540A}" dt="2025-02-07T05:08:53.160" v="6" actId="478"/>
          <ac:picMkLst>
            <pc:docMk/>
            <pc:sldMk cId="2658527185" sldId="260"/>
            <ac:picMk id="22" creationId="{42778FA8-DEEB-7D5A-7325-30FFE9A9AF19}"/>
          </ac:picMkLst>
        </pc:picChg>
        <pc:picChg chg="add mod">
          <ac:chgData name="Yoshiaki Marumo" userId="86324989ca739fff" providerId="LiveId" clId="{C4004026-7FD7-414B-B9B4-B5699943540A}" dt="2025-02-07T05:09:03.971" v="11" actId="1076"/>
          <ac:picMkLst>
            <pc:docMk/>
            <pc:sldMk cId="2658527185" sldId="260"/>
            <ac:picMk id="40" creationId="{7F00BB62-7054-E067-4C0A-BF232D666E44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216EA-535B-4D0A-BECC-4C236FB6C9D7}" type="datetimeFigureOut">
              <a:rPr kumimoji="1" lang="ja-JP" altLang="en-US" smtClean="0"/>
              <a:t>2025/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DBBA9-71F9-4A61-B272-C83F338DBF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97393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216EA-535B-4D0A-BECC-4C236FB6C9D7}" type="datetimeFigureOut">
              <a:rPr kumimoji="1" lang="ja-JP" altLang="en-US" smtClean="0"/>
              <a:t>2025/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DBBA9-71F9-4A61-B272-C83F338DBF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31121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216EA-535B-4D0A-BECC-4C236FB6C9D7}" type="datetimeFigureOut">
              <a:rPr kumimoji="1" lang="ja-JP" altLang="en-US" smtClean="0"/>
              <a:t>2025/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DBBA9-71F9-4A61-B272-C83F338DBF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51408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216EA-535B-4D0A-BECC-4C236FB6C9D7}" type="datetimeFigureOut">
              <a:rPr kumimoji="1" lang="ja-JP" altLang="en-US" smtClean="0"/>
              <a:t>2025/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DBBA9-71F9-4A61-B272-C83F338DBF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17116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216EA-535B-4D0A-BECC-4C236FB6C9D7}" type="datetimeFigureOut">
              <a:rPr kumimoji="1" lang="ja-JP" altLang="en-US" smtClean="0"/>
              <a:t>2025/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DBBA9-71F9-4A61-B272-C83F338DBF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12224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216EA-535B-4D0A-BECC-4C236FB6C9D7}" type="datetimeFigureOut">
              <a:rPr kumimoji="1" lang="ja-JP" altLang="en-US" smtClean="0"/>
              <a:t>2025/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DBBA9-71F9-4A61-B272-C83F338DBF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88228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216EA-535B-4D0A-BECC-4C236FB6C9D7}" type="datetimeFigureOut">
              <a:rPr kumimoji="1" lang="ja-JP" altLang="en-US" smtClean="0"/>
              <a:t>2025/2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DBBA9-71F9-4A61-B272-C83F338DBF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44212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216EA-535B-4D0A-BECC-4C236FB6C9D7}" type="datetimeFigureOut">
              <a:rPr kumimoji="1" lang="ja-JP" altLang="en-US" smtClean="0"/>
              <a:t>2025/2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DBBA9-71F9-4A61-B272-C83F338DBF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82840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216EA-535B-4D0A-BECC-4C236FB6C9D7}" type="datetimeFigureOut">
              <a:rPr kumimoji="1" lang="ja-JP" altLang="en-US" smtClean="0"/>
              <a:t>2025/2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DBBA9-71F9-4A61-B272-C83F338DBF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93682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216EA-535B-4D0A-BECC-4C236FB6C9D7}" type="datetimeFigureOut">
              <a:rPr kumimoji="1" lang="ja-JP" altLang="en-US" smtClean="0"/>
              <a:t>2025/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DBBA9-71F9-4A61-B272-C83F338DBF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77083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216EA-535B-4D0A-BECC-4C236FB6C9D7}" type="datetimeFigureOut">
              <a:rPr kumimoji="1" lang="ja-JP" altLang="en-US" smtClean="0"/>
              <a:t>2025/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DBBA9-71F9-4A61-B272-C83F338DBF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5478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FD216EA-535B-4D0A-BECC-4C236FB6C9D7}" type="datetimeFigureOut">
              <a:rPr kumimoji="1" lang="ja-JP" altLang="en-US" smtClean="0"/>
              <a:t>2025/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9DDBBA9-71F9-4A61-B272-C83F338DBF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98016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7" name="図 146">
            <a:extLst>
              <a:ext uri="{FF2B5EF4-FFF2-40B4-BE49-F238E27FC236}">
                <a16:creationId xmlns:a16="http://schemas.microsoft.com/office/drawing/2014/main" id="{FABE3412-B59B-E580-FF93-493ADD7A23F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97436"/>
            <a:ext cx="6745574" cy="2988019"/>
          </a:xfrm>
          <a:prstGeom prst="rect">
            <a:avLst/>
          </a:prstGeom>
        </p:spPr>
      </p:pic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EE292273-0BC4-C7FB-7A6D-F12E098D79C5}"/>
              </a:ext>
            </a:extLst>
          </p:cNvPr>
          <p:cNvSpPr txBox="1"/>
          <p:nvPr/>
        </p:nvSpPr>
        <p:spPr>
          <a:xfrm>
            <a:off x="0" y="3267856"/>
            <a:ext cx="685800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1.</a:t>
            </a:r>
            <a:r>
              <a: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ting strategy. After debris, doublet and dead cell exclusion, CD3+CD4+ or CD3+CD8+ fraction was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vided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to four subsets according to CCR7 and CD45RO positivity (CCR7</a:t>
            </a:r>
            <a:r>
              <a:rPr kumimoji="1" lang="en-U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5RO</a:t>
            </a:r>
            <a:r>
              <a:rPr kumimoji="1" lang="en-U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naïve or stem cell memory; CCR7</a:t>
            </a:r>
            <a:r>
              <a:rPr kumimoji="1" lang="en-U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5RO</a:t>
            </a:r>
            <a:r>
              <a:rPr kumimoji="1" lang="en-U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entral memory; CCR7</a:t>
            </a:r>
            <a:r>
              <a:rPr kumimoji="1" lang="en-U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5RO</a:t>
            </a:r>
            <a:r>
              <a:rPr kumimoji="1" lang="en-U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effector memory; CCR7</a:t>
            </a:r>
            <a:r>
              <a:rPr kumimoji="1" lang="en-U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5RO</a:t>
            </a:r>
            <a:r>
              <a:rPr kumimoji="1" lang="en-U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effector). CCR7, CD45RO and PD-1 positivity was assessed by fluorescence minus one gating control.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67654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FA24EDC-B1EE-B4BA-E958-CA9D1243D43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7670EF5B-4379-DDB7-FD76-D01EDD6F866A}"/>
              </a:ext>
            </a:extLst>
          </p:cNvPr>
          <p:cNvSpPr txBox="1"/>
          <p:nvPr/>
        </p:nvSpPr>
        <p:spPr>
          <a:xfrm>
            <a:off x="0" y="4281725"/>
            <a:ext cx="6858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2.</a:t>
            </a:r>
            <a:r>
              <a: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gression-free survival by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yCARe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ratification in this study cohort.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D813E26D-265F-E78B-BC6D-14513132DF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2072"/>
            <a:ext cx="6858000" cy="42296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187458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図 39">
            <a:extLst>
              <a:ext uri="{FF2B5EF4-FFF2-40B4-BE49-F238E27FC236}">
                <a16:creationId xmlns:a16="http://schemas.microsoft.com/office/drawing/2014/main" id="{7F00BB62-7054-E067-4C0A-BF232D666E4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68580" y="0"/>
            <a:ext cx="6858000" cy="3537772"/>
          </a:xfrm>
          <a:prstGeom prst="rect">
            <a:avLst/>
          </a:prstGeom>
        </p:spPr>
      </p:pic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C64764CD-084A-4D55-6371-7B010BDFA475}"/>
              </a:ext>
            </a:extLst>
          </p:cNvPr>
          <p:cNvSpPr txBox="1"/>
          <p:nvPr/>
        </p:nvSpPr>
        <p:spPr>
          <a:xfrm>
            <a:off x="0" y="3582314"/>
            <a:ext cx="685800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.</a:t>
            </a:r>
            <a:r>
              <a: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difference in proportion of CCR7+CD8 T cells analyzed by prior treatment</a:t>
            </a:r>
          </a:p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The difference in proportion of CCR7+CD8 T cells just before lymphocyte apheresis. While PIs-based or alkylator-containing chemotherapy did not prompt a difference, treatment with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iDs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based chemotherapy led to significantly more CCR7-positive CD8 T cells. B. The difference in levels of CCR7+CD8 T cells with prior bispecific antibody use over 3 months. There was no significant difference between the two groups. Abbreviations</a:t>
            </a:r>
            <a:r>
              <a: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s, proteasome inhibitors;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iDs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mmunomodulatory drugs.</a:t>
            </a:r>
          </a:p>
          <a:p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85271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F32A251-F514-603C-DF87-0519A5CBE69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FC9311E5-6973-2EB0-DEAE-C5DAB057C846}"/>
              </a:ext>
            </a:extLst>
          </p:cNvPr>
          <p:cNvSpPr txBox="1"/>
          <p:nvPr/>
        </p:nvSpPr>
        <p:spPr>
          <a:xfrm>
            <a:off x="0" y="3582314"/>
            <a:ext cx="6858000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4.</a:t>
            </a:r>
            <a:r>
              <a: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-1 positivity of CD4 or CD8 subsets by the systemic treatment prior to lymphocyte apheresis. Systemic chemotherapy with PIs resulted in the finding of significantly higher PD-1-positive CD4 central memory T cells, while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iDs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based chemotherapy just prior to lymphocyte apheresis showed significantly lower PD-1-positive CD8 central memory, effector memory, and effector T cells in apheresis samples. Abbreviations:</a:t>
            </a:r>
            <a:r>
              <a: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s, proteasome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hibitos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iDs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mmunomodulatory drugs; N, naïve or stem cell memory; CM, central memory; EM, effector memory; EF, effector.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9C3CA941-4F30-67ED-10CD-F9BFE042B8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48173"/>
            <a:ext cx="6858000" cy="3434141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8C3738F-EBCE-316E-C97C-34F9F9FFFACF}"/>
              </a:ext>
            </a:extLst>
          </p:cNvPr>
          <p:cNvSpPr txBox="1"/>
          <p:nvPr/>
        </p:nvSpPr>
        <p:spPr>
          <a:xfrm>
            <a:off x="60960" y="82986"/>
            <a:ext cx="167424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kumimoji="1" lang="en-US" altLang="ja-JP" sz="1200" dirty="0"/>
              <a:t> Figure 4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3309239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</TotalTime>
  <Words>295</Words>
  <Application>Microsoft Office PowerPoint</Application>
  <PresentationFormat>A4 210 x 297 mm</PresentationFormat>
  <Paragraphs>6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Aptos</vt:lpstr>
      <vt:lpstr>Aptos Display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oshiaki Marumo</dc:creator>
  <cp:lastModifiedBy>Yoshiaki Marumo</cp:lastModifiedBy>
  <cp:revision>3</cp:revision>
  <dcterms:created xsi:type="dcterms:W3CDTF">2024-12-30T07:00:16Z</dcterms:created>
  <dcterms:modified xsi:type="dcterms:W3CDTF">2025-02-07T05:11:16Z</dcterms:modified>
</cp:coreProperties>
</file>